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ac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2822653117840298"/>
          <c:y val="4.2328042328042326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32:$B$35</c:f>
              <c:strCache>
                <c:ptCount val="4"/>
                <c:pt idx="0">
                  <c:v>0uM</c:v>
                </c:pt>
                <c:pt idx="1">
                  <c:v>25uM</c:v>
                </c:pt>
                <c:pt idx="2">
                  <c:v>50uM</c:v>
                </c:pt>
                <c:pt idx="3">
                  <c:v>100uM</c:v>
                </c:pt>
              </c:strCache>
            </c:strRef>
          </c:cat>
          <c:val>
            <c:numRef>
              <c:f>Sheet1!$D$32:$D$35</c:f>
              <c:numCache>
                <c:formatCode>General</c:formatCode>
                <c:ptCount val="4"/>
                <c:pt idx="0">
                  <c:v>1</c:v>
                </c:pt>
                <c:pt idx="1">
                  <c:v>0.89511788818823934</c:v>
                </c:pt>
                <c:pt idx="2">
                  <c:v>1.6669862334579126</c:v>
                </c:pt>
                <c:pt idx="3">
                  <c:v>0.996949282630119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16914000"/>
        <c:axId val="316913440"/>
      </c:barChart>
      <c:catAx>
        <c:axId val="316914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16913440"/>
        <c:crosses val="autoZero"/>
        <c:auto val="1"/>
        <c:lblAlgn val="ctr"/>
        <c:lblOffset val="100"/>
        <c:noMultiLvlLbl val="0"/>
      </c:catAx>
      <c:valAx>
        <c:axId val="316913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169140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ac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5995194319929034"/>
          <c:y val="4.2105263157894736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40:$B$43</c:f>
              <c:strCache>
                <c:ptCount val="4"/>
                <c:pt idx="0">
                  <c:v>0uM</c:v>
                </c:pt>
                <c:pt idx="1">
                  <c:v>25uM</c:v>
                </c:pt>
                <c:pt idx="2">
                  <c:v>50uM</c:v>
                </c:pt>
                <c:pt idx="3">
                  <c:v>100uM</c:v>
                </c:pt>
              </c:strCache>
            </c:strRef>
          </c:cat>
          <c:val>
            <c:numRef>
              <c:f>Sheet1!$D$40:$D$43</c:f>
              <c:numCache>
                <c:formatCode>General</c:formatCode>
                <c:ptCount val="4"/>
                <c:pt idx="0">
                  <c:v>1</c:v>
                </c:pt>
                <c:pt idx="1">
                  <c:v>1.4397431324282526</c:v>
                </c:pt>
                <c:pt idx="2">
                  <c:v>1.6395506832782039</c:v>
                </c:pt>
                <c:pt idx="3">
                  <c:v>1.76658904986774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18261792"/>
        <c:axId val="318262352"/>
      </c:barChart>
      <c:catAx>
        <c:axId val="318261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18262352"/>
        <c:crosses val="autoZero"/>
        <c:auto val="1"/>
        <c:lblAlgn val="ctr"/>
        <c:lblOffset val="100"/>
        <c:noMultiLvlLbl val="0"/>
      </c:catAx>
      <c:valAx>
        <c:axId val="318262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182617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-1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5014117871736403"/>
          <c:y val="3.007518796992481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51:$B$54</c:f>
              <c:strCache>
                <c:ptCount val="4"/>
                <c:pt idx="0">
                  <c:v>con</c:v>
                </c:pt>
                <c:pt idx="1">
                  <c:v>RSV+CFZ</c:v>
                </c:pt>
                <c:pt idx="2">
                  <c:v>siR-Smac</c:v>
                </c:pt>
                <c:pt idx="3">
                  <c:v>RSV+CFZ+siR-Smac</c:v>
                </c:pt>
              </c:strCache>
            </c:strRef>
          </c:cat>
          <c:val>
            <c:numRef>
              <c:f>Sheet1!$F$51:$F$54</c:f>
              <c:numCache>
                <c:formatCode>General</c:formatCode>
                <c:ptCount val="4"/>
                <c:pt idx="0">
                  <c:v>1</c:v>
                </c:pt>
                <c:pt idx="1">
                  <c:v>0.27319632445298897</c:v>
                </c:pt>
                <c:pt idx="2">
                  <c:v>0.54025728008084339</c:v>
                </c:pt>
                <c:pt idx="3">
                  <c:v>0.153562339131111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586016"/>
        <c:axId val="321586576"/>
      </c:barChart>
      <c:catAx>
        <c:axId val="321586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86576"/>
        <c:crosses val="autoZero"/>
        <c:auto val="1"/>
        <c:lblAlgn val="ctr"/>
        <c:lblOffset val="100"/>
        <c:noMultiLvlLbl val="0"/>
      </c:catAx>
      <c:valAx>
        <c:axId val="321586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86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mac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51:$B$54</c:f>
              <c:strCache>
                <c:ptCount val="4"/>
                <c:pt idx="0">
                  <c:v>con</c:v>
                </c:pt>
                <c:pt idx="1">
                  <c:v>RSV+CFZ</c:v>
                </c:pt>
                <c:pt idx="2">
                  <c:v>siR-Smac</c:v>
                </c:pt>
                <c:pt idx="3">
                  <c:v>RSV+CFZ+siR-Smac</c:v>
                </c:pt>
              </c:strCache>
            </c:strRef>
          </c:cat>
          <c:val>
            <c:numRef>
              <c:f>Sheet1!$G$51:$G$54</c:f>
              <c:numCache>
                <c:formatCode>General</c:formatCode>
                <c:ptCount val="4"/>
                <c:pt idx="0">
                  <c:v>1</c:v>
                </c:pt>
                <c:pt idx="1">
                  <c:v>1.4133247516905432</c:v>
                </c:pt>
                <c:pt idx="2">
                  <c:v>0.94548978746848067</c:v>
                </c:pt>
                <c:pt idx="3">
                  <c:v>0.276166481588565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588816"/>
        <c:axId val="321589376"/>
      </c:barChart>
      <c:catAx>
        <c:axId val="321588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89376"/>
        <c:crosses val="autoZero"/>
        <c:auto val="1"/>
        <c:lblAlgn val="ctr"/>
        <c:lblOffset val="100"/>
        <c:noMultiLvlLbl val="0"/>
      </c:catAx>
      <c:valAx>
        <c:axId val="321589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888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in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8006171971708547"/>
          <c:y val="1.6183566364858126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51:$B$54</c:f>
              <c:strCache>
                <c:ptCount val="4"/>
                <c:pt idx="0">
                  <c:v>con</c:v>
                </c:pt>
                <c:pt idx="1">
                  <c:v>RSV+CFZ</c:v>
                </c:pt>
                <c:pt idx="2">
                  <c:v>siR-Smac</c:v>
                </c:pt>
                <c:pt idx="3">
                  <c:v>RSV+CFZ+siR-Smac</c:v>
                </c:pt>
              </c:strCache>
            </c:strRef>
          </c:cat>
          <c:val>
            <c:numRef>
              <c:f>Sheet1!$H$51:$H$54</c:f>
              <c:numCache>
                <c:formatCode>General</c:formatCode>
                <c:ptCount val="4"/>
                <c:pt idx="0">
                  <c:v>1</c:v>
                </c:pt>
                <c:pt idx="1">
                  <c:v>6.4042705966917399E-2</c:v>
                </c:pt>
                <c:pt idx="2">
                  <c:v>0.65652375668346519</c:v>
                </c:pt>
                <c:pt idx="3">
                  <c:v>7.0670121234054903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591616"/>
        <c:axId val="321592176"/>
      </c:barChart>
      <c:catAx>
        <c:axId val="321591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92176"/>
        <c:crosses val="autoZero"/>
        <c:auto val="1"/>
        <c:lblAlgn val="ctr"/>
        <c:lblOffset val="100"/>
        <c:noMultiLvlLbl val="0"/>
      </c:catAx>
      <c:valAx>
        <c:axId val="3215921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916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RT-1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5997395305853758"/>
          <c:y val="3.0476190476190476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63:$B$64</c:f>
              <c:strCache>
                <c:ptCount val="2"/>
                <c:pt idx="0">
                  <c:v>vector</c:v>
                </c:pt>
                <c:pt idx="1">
                  <c:v>SIRT1-shRNA</c:v>
                </c:pt>
              </c:strCache>
            </c:strRef>
          </c:cat>
          <c:val>
            <c:numRef>
              <c:f>Sheet1!$E$63:$E$64</c:f>
              <c:numCache>
                <c:formatCode>General</c:formatCode>
                <c:ptCount val="2"/>
                <c:pt idx="0">
                  <c:v>1</c:v>
                </c:pt>
                <c:pt idx="1">
                  <c:v>0.373556536678315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594416"/>
        <c:axId val="321594976"/>
      </c:barChart>
      <c:catAx>
        <c:axId val="321594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94976"/>
        <c:crosses val="autoZero"/>
        <c:auto val="1"/>
        <c:lblAlgn val="ctr"/>
        <c:lblOffset val="100"/>
        <c:noMultiLvlLbl val="0"/>
      </c:catAx>
      <c:valAx>
        <c:axId val="3215949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944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in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2789616573100772"/>
          <c:y val="4.6647445773688512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63:$B$64</c:f>
              <c:strCache>
                <c:ptCount val="2"/>
                <c:pt idx="0">
                  <c:v>vector</c:v>
                </c:pt>
                <c:pt idx="1">
                  <c:v>SIRT1-shRNA</c:v>
                </c:pt>
              </c:strCache>
            </c:strRef>
          </c:cat>
          <c:val>
            <c:numRef>
              <c:f>Sheet1!$F$63:$F$64</c:f>
              <c:numCache>
                <c:formatCode>General</c:formatCode>
                <c:ptCount val="2"/>
                <c:pt idx="0">
                  <c:v>1</c:v>
                </c:pt>
                <c:pt idx="1">
                  <c:v>0.721023751454176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597216"/>
        <c:axId val="321597776"/>
      </c:barChart>
      <c:catAx>
        <c:axId val="321597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97776"/>
        <c:crosses val="autoZero"/>
        <c:auto val="1"/>
        <c:lblAlgn val="ctr"/>
        <c:lblOffset val="100"/>
        <c:noMultiLvlLbl val="0"/>
      </c:catAx>
      <c:valAx>
        <c:axId val="321597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5972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IRT-1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1460666970188398"/>
          <c:y val="4.2105263157894736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69:$B$70</c:f>
              <c:strCache>
                <c:ptCount val="2"/>
                <c:pt idx="0">
                  <c:v>vector</c:v>
                </c:pt>
                <c:pt idx="1">
                  <c:v>SIRT1-shRNA</c:v>
                </c:pt>
              </c:strCache>
            </c:strRef>
          </c:cat>
          <c:val>
            <c:numRef>
              <c:f>Sheet1!$E$69:$E$70</c:f>
              <c:numCache>
                <c:formatCode>General</c:formatCode>
                <c:ptCount val="2"/>
                <c:pt idx="0">
                  <c:v>1</c:v>
                </c:pt>
                <c:pt idx="1">
                  <c:v>0.397767357453238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600016"/>
        <c:axId val="321600576"/>
      </c:barChart>
      <c:catAx>
        <c:axId val="321600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600576"/>
        <c:crosses val="autoZero"/>
        <c:auto val="1"/>
        <c:lblAlgn val="ctr"/>
        <c:lblOffset val="100"/>
        <c:noMultiLvlLbl val="0"/>
      </c:catAx>
      <c:valAx>
        <c:axId val="321600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60001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rvivin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5322529704117395"/>
          <c:y val="0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B$69:$B$70</c:f>
              <c:strCache>
                <c:ptCount val="2"/>
                <c:pt idx="0">
                  <c:v>vector</c:v>
                </c:pt>
                <c:pt idx="1">
                  <c:v>SIRT1-shRNA</c:v>
                </c:pt>
              </c:strCache>
            </c:strRef>
          </c:cat>
          <c:val>
            <c:numRef>
              <c:f>Sheet1!$F$69:$F$70</c:f>
              <c:numCache>
                <c:formatCode>General</c:formatCode>
                <c:ptCount val="2"/>
                <c:pt idx="0">
                  <c:v>1</c:v>
                </c:pt>
                <c:pt idx="1">
                  <c:v>0.921539716569786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321602816"/>
        <c:axId val="321603376"/>
      </c:barChart>
      <c:catAx>
        <c:axId val="3216028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603376"/>
        <c:crosses val="autoZero"/>
        <c:auto val="1"/>
        <c:lblAlgn val="ctr"/>
        <c:lblOffset val="100"/>
        <c:noMultiLvlLbl val="0"/>
      </c:catAx>
      <c:valAx>
        <c:axId val="321603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21602816"/>
        <c:crosses val="autoZero"/>
        <c:crossBetween val="between"/>
        <c:majorUnit val="5.000000000000001E-2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136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2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0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6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04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21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85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0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93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/>
        </p:nvGrpSpPr>
        <p:grpSpPr>
          <a:xfrm>
            <a:off x="778372" y="270441"/>
            <a:ext cx="10696317" cy="5745408"/>
            <a:chOff x="778372" y="270441"/>
            <a:chExt cx="10696317" cy="5745408"/>
          </a:xfrm>
        </p:grpSpPr>
        <p:sp>
          <p:nvSpPr>
            <p:cNvPr id="2" name="TextBox 1"/>
            <p:cNvSpPr txBox="1"/>
            <p:nvPr/>
          </p:nvSpPr>
          <p:spPr>
            <a:xfrm>
              <a:off x="803060" y="270441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5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971849" y="908732"/>
              <a:ext cx="1990333" cy="1989174"/>
              <a:chOff x="1261631" y="995720"/>
              <a:chExt cx="1990333" cy="1989174"/>
            </a:xfrm>
          </p:grpSpPr>
          <p:graphicFrame>
            <p:nvGraphicFramePr>
              <p:cNvPr id="3" name="图表 1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21209500"/>
                  </p:ext>
                </p:extLst>
              </p:nvPr>
            </p:nvGraphicFramePr>
            <p:xfrm>
              <a:off x="1384742" y="995720"/>
              <a:ext cx="1867222" cy="18002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TextBox 3"/>
              <p:cNvSpPr txBox="1"/>
              <p:nvPr/>
            </p:nvSpPr>
            <p:spPr>
              <a:xfrm rot="5400000" flipV="1">
                <a:off x="774655" y="1612488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2196577" y="2707895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P-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3057782" y="984551"/>
              <a:ext cx="1967595" cy="1986449"/>
              <a:chOff x="3553181" y="998444"/>
              <a:chExt cx="1967595" cy="1986449"/>
            </a:xfrm>
          </p:grpSpPr>
          <p:graphicFrame>
            <p:nvGraphicFramePr>
              <p:cNvPr id="7" name="图表 1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36983200"/>
                  </p:ext>
                </p:extLst>
              </p:nvPr>
            </p:nvGraphicFramePr>
            <p:xfrm>
              <a:off x="3676292" y="998444"/>
              <a:ext cx="1844484" cy="1809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 rot="5400000" flipV="1">
                <a:off x="3066205" y="1612487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354638" y="2707894"/>
                <a:ext cx="6575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.1S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5244088" y="704492"/>
              <a:ext cx="2109932" cy="2533650"/>
              <a:chOff x="5927163" y="697760"/>
              <a:chExt cx="2109932" cy="2533650"/>
            </a:xfrm>
          </p:grpSpPr>
          <p:graphicFrame>
            <p:nvGraphicFramePr>
              <p:cNvPr id="11" name="图表 1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46443151"/>
                  </p:ext>
                </p:extLst>
              </p:nvPr>
            </p:nvGraphicFramePr>
            <p:xfrm>
              <a:off x="6050274" y="697760"/>
              <a:ext cx="1986821" cy="25336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2" name="TextBox 11"/>
              <p:cNvSpPr txBox="1"/>
              <p:nvPr/>
            </p:nvSpPr>
            <p:spPr>
              <a:xfrm rot="5400000" flipV="1">
                <a:off x="5440187" y="1525500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7267868" y="719201"/>
              <a:ext cx="2055003" cy="2526918"/>
              <a:chOff x="8155231" y="704492"/>
              <a:chExt cx="2055003" cy="2526918"/>
            </a:xfrm>
          </p:grpSpPr>
          <p:graphicFrame>
            <p:nvGraphicFramePr>
              <p:cNvPr id="14" name="图表 1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05703545"/>
                  </p:ext>
                </p:extLst>
              </p:nvPr>
            </p:nvGraphicFramePr>
            <p:xfrm>
              <a:off x="8312718" y="704492"/>
              <a:ext cx="1897516" cy="252691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5" name="TextBox 14"/>
              <p:cNvSpPr txBox="1"/>
              <p:nvPr/>
            </p:nvSpPr>
            <p:spPr>
              <a:xfrm rot="5400000" flipV="1">
                <a:off x="7668255" y="1512920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9435383" y="770021"/>
              <a:ext cx="2039306" cy="2468121"/>
              <a:chOff x="9435383" y="770021"/>
              <a:chExt cx="2039306" cy="2468121"/>
            </a:xfrm>
          </p:grpSpPr>
          <p:graphicFrame>
            <p:nvGraphicFramePr>
              <p:cNvPr id="17" name="图表 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11203142"/>
                  </p:ext>
                </p:extLst>
              </p:nvPr>
            </p:nvGraphicFramePr>
            <p:xfrm>
              <a:off x="9575458" y="770021"/>
              <a:ext cx="1899231" cy="246812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8" name="TextBox 17"/>
              <p:cNvSpPr txBox="1"/>
              <p:nvPr/>
            </p:nvSpPr>
            <p:spPr>
              <a:xfrm rot="5400000" flipV="1">
                <a:off x="8948407" y="1554027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cxnSp>
          <p:nvCxnSpPr>
            <p:cNvPr id="23" name="Straight Connector 22"/>
            <p:cNvCxnSpPr/>
            <p:nvPr/>
          </p:nvCxnSpPr>
          <p:spPr>
            <a:xfrm>
              <a:off x="1446543" y="5733728"/>
              <a:ext cx="16724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2036557" y="573372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-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950536" y="3602598"/>
              <a:ext cx="1408295" cy="2069253"/>
              <a:chOff x="950536" y="3709750"/>
              <a:chExt cx="1408295" cy="1962101"/>
            </a:xfrm>
          </p:grpSpPr>
          <p:graphicFrame>
            <p:nvGraphicFramePr>
              <p:cNvPr id="20" name="图表 1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66282058"/>
                  </p:ext>
                </p:extLst>
              </p:nvPr>
            </p:nvGraphicFramePr>
            <p:xfrm>
              <a:off x="1094959" y="3709750"/>
              <a:ext cx="1263872" cy="19621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26" name="TextBox 25"/>
              <p:cNvSpPr txBox="1"/>
              <p:nvPr/>
            </p:nvSpPr>
            <p:spPr>
              <a:xfrm rot="5400000" flipV="1">
                <a:off x="463560" y="4253563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2542711" y="3602598"/>
              <a:ext cx="1316528" cy="2069253"/>
              <a:chOff x="2542711" y="3709750"/>
              <a:chExt cx="1316528" cy="1962101"/>
            </a:xfrm>
          </p:grpSpPr>
          <p:graphicFrame>
            <p:nvGraphicFramePr>
              <p:cNvPr id="21" name="图表 2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65089020"/>
                  </p:ext>
                </p:extLst>
              </p:nvPr>
            </p:nvGraphicFramePr>
            <p:xfrm>
              <a:off x="2686447" y="3709750"/>
              <a:ext cx="1172792" cy="19621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sp>
            <p:nvSpPr>
              <p:cNvPr id="27" name="TextBox 26"/>
              <p:cNvSpPr txBox="1"/>
              <p:nvPr/>
            </p:nvSpPr>
            <p:spPr>
              <a:xfrm rot="5400000" flipV="1">
                <a:off x="2055735" y="4253562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4516791" y="3602598"/>
              <a:ext cx="1416496" cy="2200097"/>
              <a:chOff x="4516791" y="3709750"/>
              <a:chExt cx="1416496" cy="2092945"/>
            </a:xfrm>
          </p:grpSpPr>
          <p:graphicFrame>
            <p:nvGraphicFramePr>
              <p:cNvPr id="25" name="图表 2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58597707"/>
                  </p:ext>
                </p:extLst>
              </p:nvPr>
            </p:nvGraphicFramePr>
            <p:xfrm>
              <a:off x="4668045" y="3709750"/>
              <a:ext cx="1265242" cy="209294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30" name="TextBox 29"/>
              <p:cNvSpPr txBox="1"/>
              <p:nvPr/>
            </p:nvSpPr>
            <p:spPr>
              <a:xfrm rot="5400000" flipV="1">
                <a:off x="4029815" y="4272635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6069581" y="3738168"/>
              <a:ext cx="1444508" cy="2057438"/>
              <a:chOff x="6223748" y="3840425"/>
              <a:chExt cx="1444508" cy="1955181"/>
            </a:xfrm>
          </p:grpSpPr>
          <p:graphicFrame>
            <p:nvGraphicFramePr>
              <p:cNvPr id="32" name="图表 2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02994668"/>
                  </p:ext>
                </p:extLst>
              </p:nvPr>
            </p:nvGraphicFramePr>
            <p:xfrm>
              <a:off x="6360609" y="3840425"/>
              <a:ext cx="1307647" cy="195518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33" name="TextBox 32"/>
              <p:cNvSpPr txBox="1"/>
              <p:nvPr/>
            </p:nvSpPr>
            <p:spPr>
              <a:xfrm rot="5400000" flipV="1">
                <a:off x="5736772" y="4335253"/>
                <a:ext cx="12201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cxnSp>
          <p:nvCxnSpPr>
            <p:cNvPr id="35" name="Straight Connector 34"/>
            <p:cNvCxnSpPr/>
            <p:nvPr/>
          </p:nvCxnSpPr>
          <p:spPr>
            <a:xfrm>
              <a:off x="5097050" y="5733728"/>
              <a:ext cx="167247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5650165" y="5738850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.1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78372" y="58070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048651" y="59787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86364" y="345028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247253" y="346970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7600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37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Ping</dc:creator>
  <cp:lastModifiedBy>Fan,Ping</cp:lastModifiedBy>
  <cp:revision>29</cp:revision>
  <dcterms:created xsi:type="dcterms:W3CDTF">2018-03-12T14:59:56Z</dcterms:created>
  <dcterms:modified xsi:type="dcterms:W3CDTF">2018-03-13T17:08:43Z</dcterms:modified>
</cp:coreProperties>
</file>